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34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3D219E-7D78-3B70-87DE-7B3ED48077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CEF2C7-EC84-709D-33BD-779F72552E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E1F8E-86FE-7B0B-340E-81C074E5D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7CBF48-704D-52E1-6EB6-0FF4A474C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E794F1-0D8C-21B6-8E0E-5A6DBDA0A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178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D77A1D-68D6-376E-093C-1B45407CA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8DBFE3-846A-1EE4-98AE-C7FBEDDB23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097D65-ED12-365B-DC54-BA6CC25C4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D33690-93E7-C1DE-8369-10C8F08D8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A7BC15-F2D8-5783-AB73-B6AE20F06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375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3BB6CD-44CF-8DED-F25A-E6DEADD6B8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BE2EC4-5928-1524-2FBA-53884E8CCD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2D3130-E861-5EA0-A6CB-B9574F5C1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770008-71DE-F5DC-3A24-2DDC23047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288041-7EBC-E957-DA0E-737E5258D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402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230967-F391-8797-FFF8-2A7A92E93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809493-CBA5-8DEA-C5AE-7B0087C11F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1248D0-C480-BC1D-612F-22A00CCE4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A6467B-B10A-B12D-B8DD-EFB46169F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DD675B-077D-36AA-44D4-AC4FD24EB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103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EFC448-BBD9-3304-1EB5-CFEF0F194B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9D3367-47CC-48E8-7ECE-F106A4A88A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DA4253-4C6E-3C7F-F6C1-DB13C6F48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CDFB83-CDDB-0B8A-0E89-606FD57DC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B968B8-4D10-DE8C-B159-CEBBE6537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718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557852-9744-67BC-8991-168F89495D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D6B9C2-D940-4863-C199-0660829932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FC11E7-9C59-2989-9C57-33C8736B7B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A991FB-FA8D-ADA0-C66D-87319AA13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4D23CC-DF3D-F0AC-A111-62C4E53A0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48303F-4747-778D-602D-6BA271524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943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47A9E-8F5A-4F1D-1ADF-E49B78594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4F2594-7CD1-0D34-46C2-B4AE07B7A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63C155-6280-9F3A-FB00-43A02BE1A5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2A4FEF-657F-4A10-9988-945CC90FBA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94B849-43B4-4B64-9BB4-BCC44FFF1C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C8DF02-48D0-16F7-9609-E88B5181B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E2764A-2E96-3940-25BC-A3C7AB499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A64FCF-DC43-1B51-AB61-F436ABB07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275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F0D516-02AF-A5C6-B207-2116BDDAA2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D71B7B-117A-841D-4FE6-5F65507F2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203008-15EB-52EC-B73C-4A5BC8ED4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7D0A2D-65ED-4C44-BCFD-1AF9E6A87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85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F3D362-1949-412A-FC33-3E4E7BAE1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88907-9C33-5BD7-E374-908DF6413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F82418-0CE4-5A17-022A-A67551C1C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716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7D089-BC99-B589-35E5-9E89240F0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06584F-085B-ED66-DD8F-A0BDA3549E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5C4ADA-8663-2659-8FCA-6E38C4DF10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AE98C4-7146-100A-CE04-6C2748821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CD516-7BF0-FF51-BEF2-A568FB272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D08176-9FA5-01F1-0656-EEBD71AF8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592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088B78-C2B2-50DE-B065-8898913DD1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1C33E3-3456-2BE1-EBD2-A2597E7FA8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AB0C58-28EC-10A9-6A4B-975B00F9AB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DE45AD-48F2-E492-7C96-B89A7FFEC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947A47-CC48-6E38-DC8E-F5D494DF8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78BE54-A4F2-F90D-D909-3B0EBC464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718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193A57-4B00-49E1-D0D9-9FAAC3CD1A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A811E2-5201-5EEA-61FE-689077EDF0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E0691C-98F8-2DC2-7352-F281153C25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22FDE6-E2A4-4F2E-96A7-1F25EDCDD7A2}" type="datetimeFigureOut">
              <a:rPr lang="en-US" smtClean="0"/>
              <a:t>1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CCBB9E-E059-5593-DBB0-03BA7A4293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F2AD3B-BB9E-1460-46A2-1EF73F6D00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E7349F1-B1DD-49FC-BCAA-463D51B7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350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F00E7C7-DA9B-A759-2238-2E0AD93B0B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9133667"/>
              </p:ext>
            </p:extLst>
          </p:nvPr>
        </p:nvGraphicFramePr>
        <p:xfrm>
          <a:off x="6143190" y="1607267"/>
          <a:ext cx="1897540" cy="14119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2" imgW="6166158" imgH="4587240" progId="SigmaPlotGraphicObject.13">
                  <p:embed/>
                </p:oleObj>
              </mc:Choice>
              <mc:Fallback>
                <p:oleObj name="SPW 14.0 Graph" r:id="rId2" imgW="6166158" imgH="4587240" progId="SigmaPlotGraphicObject.13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BE3C231-09CF-4DC2-8FD9-0D93DAA907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43190" y="1607267"/>
                        <a:ext cx="1897540" cy="14119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3DDACD9-FEF3-454E-E24A-660C437456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4799329"/>
              </p:ext>
            </p:extLst>
          </p:nvPr>
        </p:nvGraphicFramePr>
        <p:xfrm>
          <a:off x="4111625" y="3270250"/>
          <a:ext cx="1538288" cy="1674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5.0 Graph" r:id="rId4" imgW="3959417" imgH="4312870" progId="SigmaPlotGraphicObject.15">
                  <p:embed/>
                </p:oleObj>
              </mc:Choice>
              <mc:Fallback>
                <p:oleObj name="SPW 15.0 Graph" r:id="rId4" imgW="3959417" imgH="4312870" progId="SigmaPlotGraphicObject.15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09F5E09-D86D-482E-BC90-7AD1913E54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11625" y="3270250"/>
                        <a:ext cx="1538288" cy="1674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A4B37C9-315A-E1C5-06BD-5B5CE429C8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476987"/>
              </p:ext>
            </p:extLst>
          </p:nvPr>
        </p:nvGraphicFramePr>
        <p:xfrm>
          <a:off x="6092974" y="3270040"/>
          <a:ext cx="2122072" cy="169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6" imgW="5460634" imgH="4349596" progId="SigmaPlotGraphicObject.13">
                  <p:embed/>
                </p:oleObj>
              </mc:Choice>
              <mc:Fallback>
                <p:oleObj name="SPW 14.0 Graph" r:id="rId6" imgW="5460634" imgH="4349596" progId="SigmaPlotGraphicObject.13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5091904C-F34D-47FE-BCB1-CF7F4FF468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092974" y="3270040"/>
                        <a:ext cx="2122072" cy="169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03CB74E-E763-BDCA-279F-EE85781852FF}"/>
              </a:ext>
            </a:extLst>
          </p:cNvPr>
          <p:cNvSpPr txBox="1"/>
          <p:nvPr/>
        </p:nvSpPr>
        <p:spPr>
          <a:xfrm>
            <a:off x="6566766" y="3348924"/>
            <a:ext cx="6124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mMCP-1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30BD36DD-7B0F-4C40-573D-0AC66776D3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7176962"/>
              </p:ext>
            </p:extLst>
          </p:nvPr>
        </p:nvGraphicFramePr>
        <p:xfrm>
          <a:off x="4067314" y="5247511"/>
          <a:ext cx="1538722" cy="16018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8" imgW="4143702" imgH="4312870" progId="SigmaPlotGraphicObject.13">
                  <p:embed/>
                </p:oleObj>
              </mc:Choice>
              <mc:Fallback>
                <p:oleObj name="SPW 14.0 Graph" r:id="rId8" imgW="4143702" imgH="4312870" progId="SigmaPlotGraphicObject.13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22FA1675-5A18-45DC-B1DB-662E5F7E81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067314" y="5247511"/>
                        <a:ext cx="1538722" cy="16018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DCA37B20-7B94-90B3-CE03-958376C16EC0}"/>
              </a:ext>
            </a:extLst>
          </p:cNvPr>
          <p:cNvSpPr txBox="1"/>
          <p:nvPr/>
        </p:nvSpPr>
        <p:spPr>
          <a:xfrm>
            <a:off x="4626939" y="6595467"/>
            <a:ext cx="40948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T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0D5894-2E67-2449-1433-BFDDA0B2540C}"/>
              </a:ext>
            </a:extLst>
          </p:cNvPr>
          <p:cNvSpPr txBox="1"/>
          <p:nvPr/>
        </p:nvSpPr>
        <p:spPr>
          <a:xfrm>
            <a:off x="5090585" y="6595467"/>
            <a:ext cx="50113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tBHQ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AB4110-0FEF-5465-5FAE-C916C86BD247}"/>
              </a:ext>
            </a:extLst>
          </p:cNvPr>
          <p:cNvSpPr txBox="1"/>
          <p:nvPr/>
        </p:nvSpPr>
        <p:spPr>
          <a:xfrm>
            <a:off x="4513099" y="5354848"/>
            <a:ext cx="6472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GATA-3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DB8198F2-DDA3-A79A-D780-10A7A3BA0C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5310278"/>
              </p:ext>
            </p:extLst>
          </p:nvPr>
        </p:nvGraphicFramePr>
        <p:xfrm>
          <a:off x="6067706" y="5247511"/>
          <a:ext cx="1578769" cy="15851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10" imgW="4296014" imgH="4312870" progId="SigmaPlotGraphicObject.13">
                  <p:embed/>
                </p:oleObj>
              </mc:Choice>
              <mc:Fallback>
                <p:oleObj name="SPW 14.0 Graph" r:id="rId10" imgW="4296014" imgH="4312870" progId="SigmaPlotGraphicObject.13">
                  <p:embed/>
                  <p:pic>
                    <p:nvPicPr>
                      <p:cNvPr id="48" name="Object 47">
                        <a:extLst>
                          <a:ext uri="{FF2B5EF4-FFF2-40B4-BE49-F238E27FC236}">
                            <a16:creationId xmlns:a16="http://schemas.microsoft.com/office/drawing/2014/main" id="{EB117AE8-2B28-4B91-9345-DD12B267C2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067706" y="5247511"/>
                        <a:ext cx="1578769" cy="15851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4C34766E-9F76-6229-8A0B-DED5F541AEA5}"/>
              </a:ext>
            </a:extLst>
          </p:cNvPr>
          <p:cNvSpPr txBox="1"/>
          <p:nvPr/>
        </p:nvSpPr>
        <p:spPr>
          <a:xfrm>
            <a:off x="7286349" y="6416891"/>
            <a:ext cx="360126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N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CA607F5-907F-779E-C1CF-4DEFF9B06A9D}"/>
              </a:ext>
            </a:extLst>
          </p:cNvPr>
          <p:cNvSpPr txBox="1"/>
          <p:nvPr/>
        </p:nvSpPr>
        <p:spPr>
          <a:xfrm>
            <a:off x="7304766" y="6174240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5A1AD4E-21C1-27FD-A8EE-932950240B02}"/>
              </a:ext>
            </a:extLst>
          </p:cNvPr>
          <p:cNvSpPr txBox="1"/>
          <p:nvPr/>
        </p:nvSpPr>
        <p:spPr>
          <a:xfrm>
            <a:off x="6600606" y="5323008"/>
            <a:ext cx="409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IL-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9F17813-3156-0948-B565-6D956B62B585}"/>
              </a:ext>
            </a:extLst>
          </p:cNvPr>
          <p:cNvSpPr txBox="1"/>
          <p:nvPr/>
        </p:nvSpPr>
        <p:spPr>
          <a:xfrm>
            <a:off x="6675867" y="6595467"/>
            <a:ext cx="40948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T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30423A9-7FA0-D44F-970E-C145BB8C37F4}"/>
              </a:ext>
            </a:extLst>
          </p:cNvPr>
          <p:cNvSpPr txBox="1"/>
          <p:nvPr/>
        </p:nvSpPr>
        <p:spPr>
          <a:xfrm>
            <a:off x="7139513" y="6595467"/>
            <a:ext cx="501135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tBHQ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E36AF50-D8B7-01EB-D7B4-31D83FB7E639}"/>
              </a:ext>
            </a:extLst>
          </p:cNvPr>
          <p:cNvSpPr txBox="1"/>
          <p:nvPr/>
        </p:nvSpPr>
        <p:spPr>
          <a:xfrm>
            <a:off x="3831047" y="1557004"/>
            <a:ext cx="415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C3F4292-DE0C-B436-FA56-70C0DBB27F63}"/>
              </a:ext>
            </a:extLst>
          </p:cNvPr>
          <p:cNvSpPr txBox="1"/>
          <p:nvPr/>
        </p:nvSpPr>
        <p:spPr>
          <a:xfrm>
            <a:off x="3860773" y="3083468"/>
            <a:ext cx="385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E7977A3-806C-685E-90CC-CDFF9CD8C716}"/>
              </a:ext>
            </a:extLst>
          </p:cNvPr>
          <p:cNvSpPr txBox="1"/>
          <p:nvPr/>
        </p:nvSpPr>
        <p:spPr>
          <a:xfrm>
            <a:off x="3784257" y="5075655"/>
            <a:ext cx="553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80DF5D0-FFC1-8B15-EF65-DF3A3764A526}"/>
              </a:ext>
            </a:extLst>
          </p:cNvPr>
          <p:cNvSpPr txBox="1"/>
          <p:nvPr/>
        </p:nvSpPr>
        <p:spPr>
          <a:xfrm>
            <a:off x="5930542" y="3083467"/>
            <a:ext cx="370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8672FAC-3883-19CE-3052-8E1E31D18E6B}"/>
              </a:ext>
            </a:extLst>
          </p:cNvPr>
          <p:cNvSpPr txBox="1"/>
          <p:nvPr/>
        </p:nvSpPr>
        <p:spPr>
          <a:xfrm>
            <a:off x="5927127" y="5090482"/>
            <a:ext cx="501138" cy="285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F307043-2A97-218C-35FC-EE5D90A7753D}"/>
              </a:ext>
            </a:extLst>
          </p:cNvPr>
          <p:cNvSpPr txBox="1"/>
          <p:nvPr/>
        </p:nvSpPr>
        <p:spPr>
          <a:xfrm>
            <a:off x="1880509" y="6432587"/>
            <a:ext cx="9537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Fig. 6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EB34F1C-B250-D31F-2067-4FC672836C29}"/>
              </a:ext>
            </a:extLst>
          </p:cNvPr>
          <p:cNvGrpSpPr/>
          <p:nvPr/>
        </p:nvGrpSpPr>
        <p:grpSpPr>
          <a:xfrm>
            <a:off x="4057874" y="1583610"/>
            <a:ext cx="1942599" cy="1435576"/>
            <a:chOff x="4159474" y="745879"/>
            <a:chExt cx="1942599" cy="1435576"/>
          </a:xfrm>
        </p:grpSpPr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5C4CB363-4E7D-5CCA-C044-EADD877C990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79274145"/>
                </p:ext>
              </p:extLst>
            </p:nvPr>
          </p:nvGraphicFramePr>
          <p:xfrm>
            <a:off x="4159474" y="745879"/>
            <a:ext cx="1942599" cy="143557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SPW 14.0 Graph" r:id="rId12" imgW="6240878" imgH="4611724" progId="SigmaPlotGraphicObject.13">
                    <p:embed/>
                  </p:oleObj>
                </mc:Choice>
                <mc:Fallback>
                  <p:oleObj name="SPW 14.0 Graph" r:id="rId12" imgW="6240878" imgH="4611724" progId="SigmaPlotGraphicObject.13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428F76D3-4928-4E21-8EBC-AF500F496FC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159474" y="745879"/>
                          <a:ext cx="1942599" cy="143557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1036BB4-22F2-9661-38FD-FC910E969BB1}"/>
                </a:ext>
              </a:extLst>
            </p:cNvPr>
            <p:cNvSpPr txBox="1"/>
            <p:nvPr/>
          </p:nvSpPr>
          <p:spPr>
            <a:xfrm>
              <a:off x="4585625" y="818277"/>
              <a:ext cx="735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ild-Type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A12A7AC-121D-669C-761F-23F9C6C2939B}"/>
                </a:ext>
              </a:extLst>
            </p:cNvPr>
            <p:cNvSpPr txBox="1"/>
            <p:nvPr/>
          </p:nvSpPr>
          <p:spPr>
            <a:xfrm>
              <a:off x="5190537" y="1099446"/>
              <a:ext cx="261461" cy="2654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25" dirty="0"/>
                <a:t>*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043CEF9-206A-D36D-3F59-E235E4CC0F3A}"/>
                </a:ext>
              </a:extLst>
            </p:cNvPr>
            <p:cNvSpPr txBox="1"/>
            <p:nvPr/>
          </p:nvSpPr>
          <p:spPr>
            <a:xfrm>
              <a:off x="5540041" y="977067"/>
              <a:ext cx="261461" cy="2654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25" dirty="0"/>
                <a:t>*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CFC15BFB-FCCE-37FD-FA1F-90A6EC770E69}"/>
              </a:ext>
            </a:extLst>
          </p:cNvPr>
          <p:cNvSpPr txBox="1"/>
          <p:nvPr/>
        </p:nvSpPr>
        <p:spPr>
          <a:xfrm>
            <a:off x="6824074" y="6185732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1EA5C3C-2C89-46D3-AA5B-565E4708EE18}"/>
              </a:ext>
            </a:extLst>
          </p:cNvPr>
          <p:cNvSpPr txBox="1"/>
          <p:nvPr/>
        </p:nvSpPr>
        <p:spPr>
          <a:xfrm>
            <a:off x="5200074" y="5976371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3850998-4832-6EFF-B212-03D03F936322}"/>
              </a:ext>
            </a:extLst>
          </p:cNvPr>
          <p:cNvSpPr txBox="1"/>
          <p:nvPr/>
        </p:nvSpPr>
        <p:spPr>
          <a:xfrm>
            <a:off x="4705204" y="5991769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3F61496-EB5C-0352-E974-8C92C36F2956}"/>
              </a:ext>
            </a:extLst>
          </p:cNvPr>
          <p:cNvSpPr txBox="1"/>
          <p:nvPr/>
        </p:nvSpPr>
        <p:spPr>
          <a:xfrm>
            <a:off x="5028701" y="5375817"/>
            <a:ext cx="5267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3584902-E224-5E0C-24DF-E2B77CBEA643}"/>
              </a:ext>
            </a:extLst>
          </p:cNvPr>
          <p:cNvSpPr txBox="1"/>
          <p:nvPr/>
        </p:nvSpPr>
        <p:spPr>
          <a:xfrm>
            <a:off x="7292592" y="4103911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60F7EAB-AE9F-CEC2-9C93-BCA4F7F2D77C}"/>
              </a:ext>
            </a:extLst>
          </p:cNvPr>
          <p:cNvSpPr txBox="1"/>
          <p:nvPr/>
        </p:nvSpPr>
        <p:spPr>
          <a:xfrm>
            <a:off x="6777844" y="4079553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2EF8955-2547-97C7-9288-A37C30422A38}"/>
              </a:ext>
            </a:extLst>
          </p:cNvPr>
          <p:cNvSpPr txBox="1"/>
          <p:nvPr/>
        </p:nvSpPr>
        <p:spPr>
          <a:xfrm>
            <a:off x="7111280" y="3304577"/>
            <a:ext cx="5267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0113D36-BA70-2BD2-E343-1C83C9712E25}"/>
              </a:ext>
            </a:extLst>
          </p:cNvPr>
          <p:cNvSpPr txBox="1"/>
          <p:nvPr/>
        </p:nvSpPr>
        <p:spPr>
          <a:xfrm>
            <a:off x="5246276" y="4143167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B59CB4A-6241-B646-6711-B0FF671833D6}"/>
              </a:ext>
            </a:extLst>
          </p:cNvPr>
          <p:cNvSpPr txBox="1"/>
          <p:nvPr/>
        </p:nvSpPr>
        <p:spPr>
          <a:xfrm>
            <a:off x="4731528" y="4118809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AB233D3-3DD9-7ADC-F231-0331C4B95023}"/>
              </a:ext>
            </a:extLst>
          </p:cNvPr>
          <p:cNvSpPr txBox="1"/>
          <p:nvPr/>
        </p:nvSpPr>
        <p:spPr>
          <a:xfrm>
            <a:off x="4534601" y="3283824"/>
            <a:ext cx="612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Clinical Scores</a:t>
            </a:r>
          </a:p>
        </p:txBody>
      </p:sp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CD4DD472-24B5-2C0B-480F-F863A2EE3F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5134072"/>
              </p:ext>
            </p:extLst>
          </p:nvPr>
        </p:nvGraphicFramePr>
        <p:xfrm>
          <a:off x="4053521" y="22346"/>
          <a:ext cx="1844062" cy="15894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14" imgW="5046084" imgH="4349596" progId="SigmaPlotGraphicObject.13">
                  <p:embed/>
                </p:oleObj>
              </mc:Choice>
              <mc:Fallback>
                <p:oleObj name="SPW 14.0 Graph" r:id="rId14" imgW="5046084" imgH="4349596" progId="SigmaPlotGraphicObject.13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914E99F-A45E-2C20-0913-DAA5BBCEA2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053521" y="22346"/>
                        <a:ext cx="1844062" cy="15894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D27A98B6-53FE-6CEE-A480-F5627CDCC7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2917915"/>
              </p:ext>
            </p:extLst>
          </p:nvPr>
        </p:nvGraphicFramePr>
        <p:xfrm>
          <a:off x="6075935" y="32319"/>
          <a:ext cx="1527612" cy="1588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4.0 Graph" r:id="rId16" imgW="4148372" imgH="4312870" progId="SigmaPlotGraphicObject.13">
                  <p:embed/>
                </p:oleObj>
              </mc:Choice>
              <mc:Fallback>
                <p:oleObj name="SPW 14.0 Graph" r:id="rId16" imgW="4148372" imgH="4312870" progId="SigmaPlotGraphicObject.13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8A04CAD-71E5-D2E4-91CE-D5AE1148F1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075935" y="32319"/>
                        <a:ext cx="1527612" cy="1588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TextBox 43">
            <a:extLst>
              <a:ext uri="{FF2B5EF4-FFF2-40B4-BE49-F238E27FC236}">
                <a16:creationId xmlns:a16="http://schemas.microsoft.com/office/drawing/2014/main" id="{ECD522BA-77EE-ECB5-9276-B7B321947F60}"/>
              </a:ext>
            </a:extLst>
          </p:cNvPr>
          <p:cNvSpPr txBox="1"/>
          <p:nvPr/>
        </p:nvSpPr>
        <p:spPr>
          <a:xfrm>
            <a:off x="4516565" y="121580"/>
            <a:ext cx="1111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OVA-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E3242A2-359D-7BE4-78FB-1995EC7EBDDC}"/>
              </a:ext>
            </a:extLst>
          </p:cNvPr>
          <p:cNvSpPr txBox="1"/>
          <p:nvPr/>
        </p:nvSpPr>
        <p:spPr>
          <a:xfrm>
            <a:off x="6539420" y="111455"/>
            <a:ext cx="11110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OVA-IgG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36C33C8-9D88-AC31-9427-1EED010DFEA9}"/>
              </a:ext>
            </a:extLst>
          </p:cNvPr>
          <p:cNvSpPr txBox="1"/>
          <p:nvPr/>
        </p:nvSpPr>
        <p:spPr>
          <a:xfrm>
            <a:off x="3831047" y="30148"/>
            <a:ext cx="415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3204244-3D92-D013-1A38-0EDC91F7DC97}"/>
              </a:ext>
            </a:extLst>
          </p:cNvPr>
          <p:cNvSpPr txBox="1"/>
          <p:nvPr/>
        </p:nvSpPr>
        <p:spPr>
          <a:xfrm>
            <a:off x="5892303" y="30148"/>
            <a:ext cx="3553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F60360A-177F-8D2E-F51C-7D6FA4340CB8}"/>
              </a:ext>
            </a:extLst>
          </p:cNvPr>
          <p:cNvSpPr txBox="1"/>
          <p:nvPr/>
        </p:nvSpPr>
        <p:spPr>
          <a:xfrm>
            <a:off x="6803083" y="6416891"/>
            <a:ext cx="360126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b="1" dirty="0"/>
              <a:t>N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E863522-D049-DC4C-97C4-EA782C5A7AA6}"/>
              </a:ext>
            </a:extLst>
          </p:cNvPr>
          <p:cNvSpPr txBox="1"/>
          <p:nvPr/>
        </p:nvSpPr>
        <p:spPr>
          <a:xfrm>
            <a:off x="4562069" y="1359873"/>
            <a:ext cx="40948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T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9BB6E1E-1BC8-2807-02C3-F379A9CB4A65}"/>
              </a:ext>
            </a:extLst>
          </p:cNvPr>
          <p:cNvSpPr txBox="1"/>
          <p:nvPr/>
        </p:nvSpPr>
        <p:spPr>
          <a:xfrm>
            <a:off x="4982683" y="1359873"/>
            <a:ext cx="50113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tBHQ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00EBE01-B7FB-AE47-B47F-E6D87B368441}"/>
              </a:ext>
            </a:extLst>
          </p:cNvPr>
          <p:cNvSpPr txBox="1"/>
          <p:nvPr/>
        </p:nvSpPr>
        <p:spPr>
          <a:xfrm>
            <a:off x="6686294" y="1359873"/>
            <a:ext cx="40948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TL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8AC05B4-1B54-82FA-9586-C6D744D9486B}"/>
              </a:ext>
            </a:extLst>
          </p:cNvPr>
          <p:cNvSpPr txBox="1"/>
          <p:nvPr/>
        </p:nvSpPr>
        <p:spPr>
          <a:xfrm>
            <a:off x="7149940" y="1359873"/>
            <a:ext cx="501135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tBHQ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CE8BBCA-651C-E31E-56BD-EDEB4A7EBD5F}"/>
              </a:ext>
            </a:extLst>
          </p:cNvPr>
          <p:cNvSpPr txBox="1"/>
          <p:nvPr/>
        </p:nvSpPr>
        <p:spPr>
          <a:xfrm>
            <a:off x="7203766" y="815321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1A948C7-6224-5117-43A1-247EE3B243BB}"/>
              </a:ext>
            </a:extLst>
          </p:cNvPr>
          <p:cNvSpPr txBox="1"/>
          <p:nvPr/>
        </p:nvSpPr>
        <p:spPr>
          <a:xfrm>
            <a:off x="6732050" y="747931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17D393E-B608-5CA7-2972-3E631E5267FB}"/>
              </a:ext>
            </a:extLst>
          </p:cNvPr>
          <p:cNvSpPr txBox="1"/>
          <p:nvPr/>
        </p:nvSpPr>
        <p:spPr>
          <a:xfrm>
            <a:off x="5166800" y="693325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002368E-4601-EFE9-5F1D-6B53F096ED21}"/>
              </a:ext>
            </a:extLst>
          </p:cNvPr>
          <p:cNvSpPr txBox="1"/>
          <p:nvPr/>
        </p:nvSpPr>
        <p:spPr>
          <a:xfrm>
            <a:off x="4695084" y="711999"/>
            <a:ext cx="2614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86ED7DE-ED34-A0FF-6787-F1CBAD130F5A}"/>
              </a:ext>
            </a:extLst>
          </p:cNvPr>
          <p:cNvSpPr txBox="1"/>
          <p:nvPr/>
        </p:nvSpPr>
        <p:spPr>
          <a:xfrm>
            <a:off x="6684967" y="1656008"/>
            <a:ext cx="6605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rf2-nul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933E317-AD9E-E7E8-1DF4-2645315455AA}"/>
              </a:ext>
            </a:extLst>
          </p:cNvPr>
          <p:cNvSpPr txBox="1"/>
          <p:nvPr/>
        </p:nvSpPr>
        <p:spPr>
          <a:xfrm>
            <a:off x="5978367" y="1557004"/>
            <a:ext cx="3553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1791287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4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SPW 14.0 Graph</vt:lpstr>
      <vt:lpstr>SigmaPlot 15.0 Graph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ckwell, Cheryl</dc:creator>
  <cp:lastModifiedBy>Rockwell, Cheryl</cp:lastModifiedBy>
  <cp:revision>1</cp:revision>
  <dcterms:created xsi:type="dcterms:W3CDTF">2025-01-30T03:55:49Z</dcterms:created>
  <dcterms:modified xsi:type="dcterms:W3CDTF">2025-01-30T04:09:28Z</dcterms:modified>
</cp:coreProperties>
</file>